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7" r:id="rId3"/>
    <p:sldId id="294" r:id="rId5"/>
    <p:sldId id="270" r:id="rId6"/>
    <p:sldId id="271" r:id="rId7"/>
    <p:sldId id="272" r:id="rId8"/>
    <p:sldId id="292" r:id="rId9"/>
    <p:sldId id="293" r:id="rId10"/>
    <p:sldId id="289" r:id="rId11"/>
  </p:sldIdLst>
  <p:sldSz cx="9144000" cy="6858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0203" autoAdjust="0"/>
  </p:normalViewPr>
  <p:slideViewPr>
    <p:cSldViewPr snapToGrid="0">
      <p:cViewPr varScale="1">
        <p:scale>
          <a:sx n="70" d="100"/>
          <a:sy n="70" d="100"/>
        </p:scale>
        <p:origin x="1326" y="78"/>
      </p:cViewPr>
      <p:guideLst>
        <p:guide orient="horz" pos="2158"/>
        <p:guide pos="285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&#24352;&#20122;\Desktop\MdMYB88124%20&#26681;&#27687;&#21270;&#29289;&#19982;&#21494;&#20195;&#35874;&#29289;%20&#38271;&#26399;&#24178;&#26097;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C:\Users\&#24352;&#20122;\Desktop\MdMYB88124%20&#26681;&#27687;&#21270;&#29289;&#19982;&#21494;&#20195;&#35874;&#29289;%20&#38271;&#26399;&#24178;&#26097;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C:\Users\&#24352;&#20122;\Desktop\MdMYB88124%20&#26681;&#27687;&#21270;&#29289;&#19982;&#21494;&#20195;&#35874;&#29289;%20&#38271;&#26399;&#24178;&#26097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C:\Users\&#24352;&#20122;\Desktop\MdMYB88124%20&#26681;&#27687;&#21270;&#29289;&#19982;&#21494;&#20195;&#35874;&#29289;%20&#38271;&#26399;&#24178;&#2609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03691275167785"/>
          <c:y val="0.0584950810954533"/>
          <c:w val="0.872718120805369"/>
          <c:h val="0.73775714622998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dMYB88124 根氧化物与叶代谢物 长期干旱.xlsx]Sheet3'!$B$118</c:f>
              <c:strCache>
                <c:ptCount val="1"/>
                <c:pt idx="0">
                  <c:v>GL-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18:$F$118</c:f>
                <c:numCache>
                  <c:formatCode>General</c:formatCode>
                  <c:ptCount val="2"/>
                  <c:pt idx="0">
                    <c:v>17.3861059610435</c:v>
                  </c:pt>
                  <c:pt idx="1">
                    <c:v>40.4473410982927</c:v>
                  </c:pt>
                </c:numCache>
              </c:numRef>
            </c:plus>
            <c:minus>
              <c:numRef>
                <c:f>'[MdMYB88124 根氧化物与叶代谢物 长期干旱.xlsx]Sheet3'!$E$118:$F$118</c:f>
                <c:numCache>
                  <c:formatCode>General</c:formatCode>
                  <c:ptCount val="2"/>
                  <c:pt idx="0">
                    <c:v>17.3861059610435</c:v>
                  </c:pt>
                  <c:pt idx="1">
                    <c:v>40.44734109829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17:$D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18:$D$118</c:f>
              <c:numCache>
                <c:formatCode>General</c:formatCode>
                <c:ptCount val="2"/>
                <c:pt idx="0">
                  <c:v>342.062593333333</c:v>
                </c:pt>
                <c:pt idx="1">
                  <c:v>232.953826666667</c:v>
                </c:pt>
              </c:numCache>
            </c:numRef>
          </c:val>
        </c:ser>
        <c:ser>
          <c:idx val="1"/>
          <c:order val="1"/>
          <c:tx>
            <c:strRef>
              <c:f>'[MdMYB88124 根氧化物与叶代谢物 长期干旱.xlsx]Sheet3'!$B$119</c:f>
              <c:strCache>
                <c:ptCount val="1"/>
                <c:pt idx="0">
                  <c:v>MdMYB88/124 RNAi #2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19:$F$119</c:f>
                <c:numCache>
                  <c:formatCode>General</c:formatCode>
                  <c:ptCount val="2"/>
                  <c:pt idx="0">
                    <c:v>14.861671899349</c:v>
                  </c:pt>
                  <c:pt idx="1">
                    <c:v>23.2569794571443</c:v>
                  </c:pt>
                </c:numCache>
              </c:numRef>
            </c:plus>
            <c:minus>
              <c:numRef>
                <c:f>'[MdMYB88124 根氧化物与叶代谢物 长期干旱.xlsx]Sheet3'!$E$119:$F$119</c:f>
                <c:numCache>
                  <c:formatCode>General</c:formatCode>
                  <c:ptCount val="2"/>
                  <c:pt idx="0">
                    <c:v>14.861671899349</c:v>
                  </c:pt>
                  <c:pt idx="1">
                    <c:v>23.25697945714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17:$D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19:$D$119</c:f>
              <c:numCache>
                <c:formatCode>General</c:formatCode>
                <c:ptCount val="2"/>
                <c:pt idx="0">
                  <c:v>313.13342</c:v>
                </c:pt>
                <c:pt idx="1">
                  <c:v>206.933856666667</c:v>
                </c:pt>
              </c:numCache>
            </c:numRef>
          </c:val>
        </c:ser>
        <c:ser>
          <c:idx val="2"/>
          <c:order val="2"/>
          <c:tx>
            <c:strRef>
              <c:f>'[MdMYB88124 根氧化物与叶代谢物 长期干旱.xlsx]Sheet3'!$B$120</c:f>
              <c:strCache>
                <c:ptCount val="1"/>
                <c:pt idx="0">
                  <c:v>MdMYB88/124 RNAi #2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F$92:$G$92</c:f>
                <c:numCache>
                  <c:formatCode>General</c:formatCode>
                  <c:ptCount val="2"/>
                  <c:pt idx="0">
                    <c:v>20.4937714333575</c:v>
                  </c:pt>
                  <c:pt idx="1">
                    <c:v>7.33281497324868</c:v>
                  </c:pt>
                </c:numCache>
              </c:numRef>
            </c:plus>
            <c:minus>
              <c:numRef>
                <c:f>'[MdMYB88124 根氧化物与叶代谢物 长期干旱.xlsx]Sheet3'!$F$92:$G$92</c:f>
                <c:numCache>
                  <c:formatCode>General</c:formatCode>
                  <c:ptCount val="2"/>
                  <c:pt idx="0">
                    <c:v>20.4937714333575</c:v>
                  </c:pt>
                  <c:pt idx="1">
                    <c:v>7.332814973248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17:$D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20:$D$120</c:f>
              <c:numCache>
                <c:formatCode>General</c:formatCode>
                <c:ptCount val="2"/>
                <c:pt idx="0">
                  <c:v>316.91129</c:v>
                </c:pt>
                <c:pt idx="1">
                  <c:v>200.032156666667</c:v>
                </c:pt>
              </c:numCache>
            </c:numRef>
          </c:val>
        </c:ser>
        <c:ser>
          <c:idx val="3"/>
          <c:order val="3"/>
          <c:tx>
            <c:strRef>
              <c:f>'[MdMYB88124 根氧化物与叶代谢物 长期干旱.xlsx]Sheet3'!$B$121</c:f>
              <c:strCache>
                <c:ptCount val="1"/>
                <c:pt idx="0">
                  <c:v>MdMYB88 OE #29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F$93:$G$93</c:f>
                <c:numCache>
                  <c:formatCode>General</c:formatCode>
                  <c:ptCount val="2"/>
                  <c:pt idx="0">
                    <c:v>54.0531759033383</c:v>
                  </c:pt>
                  <c:pt idx="1">
                    <c:v>47.8586696936097</c:v>
                  </c:pt>
                </c:numCache>
              </c:numRef>
            </c:plus>
            <c:minus>
              <c:numRef>
                <c:f>'[MdMYB88124 根氧化物与叶代谢物 长期干旱.xlsx]Sheet3'!$F$93:$G$93</c:f>
                <c:numCache>
                  <c:formatCode>General</c:formatCode>
                  <c:ptCount val="2"/>
                  <c:pt idx="0">
                    <c:v>54.0531759033383</c:v>
                  </c:pt>
                  <c:pt idx="1">
                    <c:v>47.85866969360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17:$D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21:$D$121</c:f>
              <c:numCache>
                <c:formatCode>General</c:formatCode>
                <c:ptCount val="2"/>
                <c:pt idx="0">
                  <c:v>309.617516666667</c:v>
                </c:pt>
                <c:pt idx="1">
                  <c:v>239.0097</c:v>
                </c:pt>
              </c:numCache>
            </c:numRef>
          </c:val>
        </c:ser>
        <c:ser>
          <c:idx val="4"/>
          <c:order val="4"/>
          <c:tx>
            <c:strRef>
              <c:f>'[MdMYB88124 根氧化物与叶代谢物 长期干旱.xlsx]Sheet3'!$B$122</c:f>
              <c:strCache>
                <c:ptCount val="1"/>
                <c:pt idx="0">
                  <c:v>MdMYB124 OE #10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F$94:$G$94</c:f>
                <c:numCache>
                  <c:formatCode>General</c:formatCode>
                  <c:ptCount val="2"/>
                  <c:pt idx="0">
                    <c:v>40.1101368026737</c:v>
                  </c:pt>
                  <c:pt idx="1">
                    <c:v>11.3063628409007</c:v>
                  </c:pt>
                </c:numCache>
              </c:numRef>
            </c:plus>
            <c:minus>
              <c:numRef>
                <c:f>'[MdMYB88124 根氧化物与叶代谢物 长期干旱.xlsx]Sheet3'!$F$94:$G$94</c:f>
                <c:numCache>
                  <c:formatCode>General</c:formatCode>
                  <c:ptCount val="2"/>
                  <c:pt idx="0">
                    <c:v>40.1101368026737</c:v>
                  </c:pt>
                  <c:pt idx="1">
                    <c:v>11.3063628409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17:$D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22:$D$122</c:f>
              <c:numCache>
                <c:formatCode>General</c:formatCode>
                <c:ptCount val="2"/>
                <c:pt idx="0">
                  <c:v>324.590996666667</c:v>
                </c:pt>
                <c:pt idx="1">
                  <c:v>256.880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5327248"/>
        <c:axId val="1465316368"/>
      </c:barChart>
      <c:catAx>
        <c:axId val="14653272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16368"/>
        <c:crosses val="autoZero"/>
        <c:auto val="1"/>
        <c:lblAlgn val="ctr"/>
        <c:lblOffset val="100"/>
        <c:noMultiLvlLbl val="0"/>
      </c:catAx>
      <c:valAx>
        <c:axId val="1465316368"/>
        <c:scaling>
          <c:orientation val="minMax"/>
          <c:max val="6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27248"/>
        <c:crosses val="autoZero"/>
        <c:crossBetween val="between"/>
        <c:majorUnit val="20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433077765607886"/>
          <c:y val="0.0603948896631823"/>
          <c:w val="0.560350492880613"/>
          <c:h val="0.32984901277584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30288976097"/>
          <c:y val="0.0445161290322581"/>
          <c:w val="0.83863717445594"/>
          <c:h val="0.8227096774193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dMYB88124 根氧化物与叶代谢物 长期干旱.xlsx]Sheet3'!$I$118</c:f>
              <c:strCache>
                <c:ptCount val="1"/>
                <c:pt idx="0">
                  <c:v>GL-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L$118:$M$118</c:f>
                <c:numCache>
                  <c:formatCode>General</c:formatCode>
                  <c:ptCount val="2"/>
                  <c:pt idx="0">
                    <c:v>613.578366872207</c:v>
                  </c:pt>
                  <c:pt idx="1">
                    <c:v>816.612344475124</c:v>
                  </c:pt>
                </c:numCache>
              </c:numRef>
            </c:plus>
            <c:minus>
              <c:numRef>
                <c:f>'[MdMYB88124 根氧化物与叶代谢物 长期干旱.xlsx]Sheet3'!$L$118:$M$118</c:f>
                <c:numCache>
                  <c:formatCode>General</c:formatCode>
                  <c:ptCount val="2"/>
                  <c:pt idx="0">
                    <c:v>613.578366872207</c:v>
                  </c:pt>
                  <c:pt idx="1">
                    <c:v>816.6123444751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J$117:$K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J$118:$K$118</c:f>
              <c:numCache>
                <c:formatCode>General</c:formatCode>
                <c:ptCount val="2"/>
                <c:pt idx="0">
                  <c:v>17381.9368733333</c:v>
                </c:pt>
                <c:pt idx="1">
                  <c:v>11533.83338</c:v>
                </c:pt>
              </c:numCache>
            </c:numRef>
          </c:val>
        </c:ser>
        <c:ser>
          <c:idx val="1"/>
          <c:order val="1"/>
          <c:tx>
            <c:strRef>
              <c:f>'[MdMYB88124 根氧化物与叶代谢物 长期干旱.xlsx]Sheet3'!$I$119</c:f>
              <c:strCache>
                <c:ptCount val="1"/>
                <c:pt idx="0">
                  <c:v>MdMYB88/124 RNAi #2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L$119:$M$119</c:f>
                <c:numCache>
                  <c:formatCode>General</c:formatCode>
                  <c:ptCount val="2"/>
                  <c:pt idx="0">
                    <c:v>112.177894146408</c:v>
                  </c:pt>
                  <c:pt idx="1">
                    <c:v>530.404850956335</c:v>
                  </c:pt>
                </c:numCache>
              </c:numRef>
            </c:plus>
            <c:minus>
              <c:numRef>
                <c:f>'[MdMYB88124 根氧化物与叶代谢物 长期干旱.xlsx]Sheet3'!$L$119:$M$119</c:f>
                <c:numCache>
                  <c:formatCode>General</c:formatCode>
                  <c:ptCount val="2"/>
                  <c:pt idx="0">
                    <c:v>112.177894146408</c:v>
                  </c:pt>
                  <c:pt idx="1">
                    <c:v>530.4048509563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J$117:$K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J$119:$K$119</c:f>
              <c:numCache>
                <c:formatCode>General</c:formatCode>
                <c:ptCount val="2"/>
                <c:pt idx="0">
                  <c:v>19577.4625933333</c:v>
                </c:pt>
                <c:pt idx="1">
                  <c:v>14384.5707166667</c:v>
                </c:pt>
              </c:numCache>
            </c:numRef>
          </c:val>
        </c:ser>
        <c:ser>
          <c:idx val="2"/>
          <c:order val="2"/>
          <c:tx>
            <c:strRef>
              <c:f>'[MdMYB88124 根氧化物与叶代谢物 长期干旱.xlsx]Sheet3'!$I$120</c:f>
              <c:strCache>
                <c:ptCount val="1"/>
                <c:pt idx="0">
                  <c:v>MdMYB88/124 RNAi #2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L$120:$M$120</c:f>
                <c:numCache>
                  <c:formatCode>General</c:formatCode>
                  <c:ptCount val="2"/>
                  <c:pt idx="0">
                    <c:v>946.421326783842</c:v>
                  </c:pt>
                  <c:pt idx="1">
                    <c:v>2274.1045399111</c:v>
                  </c:pt>
                </c:numCache>
              </c:numRef>
            </c:plus>
            <c:minus>
              <c:numRef>
                <c:f>'[MdMYB88124 根氧化物与叶代谢物 长期干旱.xlsx]Sheet3'!$L$120:$M$120</c:f>
                <c:numCache>
                  <c:formatCode>General</c:formatCode>
                  <c:ptCount val="2"/>
                  <c:pt idx="0">
                    <c:v>946.421326783842</c:v>
                  </c:pt>
                  <c:pt idx="1">
                    <c:v>2274.10453991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J$117:$K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J$120:$K$120</c:f>
              <c:numCache>
                <c:formatCode>General</c:formatCode>
                <c:ptCount val="2"/>
                <c:pt idx="0">
                  <c:v>20371.8716966667</c:v>
                </c:pt>
                <c:pt idx="1">
                  <c:v>14943.2178433333</c:v>
                </c:pt>
              </c:numCache>
            </c:numRef>
          </c:val>
        </c:ser>
        <c:ser>
          <c:idx val="3"/>
          <c:order val="3"/>
          <c:tx>
            <c:strRef>
              <c:f>'[MdMYB88124 根氧化物与叶代谢物 长期干旱.xlsx]Sheet3'!$I$121</c:f>
              <c:strCache>
                <c:ptCount val="1"/>
                <c:pt idx="0">
                  <c:v>MdMYB88 OE #29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L$121:$M$121</c:f>
                <c:numCache>
                  <c:formatCode>General</c:formatCode>
                  <c:ptCount val="2"/>
                  <c:pt idx="0">
                    <c:v>929.895749701067</c:v>
                  </c:pt>
                  <c:pt idx="1">
                    <c:v>2644.57500008709</c:v>
                  </c:pt>
                </c:numCache>
              </c:numRef>
            </c:plus>
            <c:minus>
              <c:numRef>
                <c:f>'[MdMYB88124 根氧化物与叶代谢物 长期干旱.xlsx]Sheet3'!$L$121:$M$121</c:f>
                <c:numCache>
                  <c:formatCode>General</c:formatCode>
                  <c:ptCount val="2"/>
                  <c:pt idx="0">
                    <c:v>929.895749701067</c:v>
                  </c:pt>
                  <c:pt idx="1">
                    <c:v>2644.575000087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J$117:$K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J$121:$K$121</c:f>
              <c:numCache>
                <c:formatCode>General</c:formatCode>
                <c:ptCount val="2"/>
                <c:pt idx="0">
                  <c:v>19459.0586133333</c:v>
                </c:pt>
                <c:pt idx="1">
                  <c:v>14167.28822</c:v>
                </c:pt>
              </c:numCache>
            </c:numRef>
          </c:val>
        </c:ser>
        <c:ser>
          <c:idx val="4"/>
          <c:order val="4"/>
          <c:tx>
            <c:strRef>
              <c:f>'[MdMYB88124 根氧化物与叶代谢物 长期干旱.xlsx]Sheet3'!$I$122</c:f>
              <c:strCache>
                <c:ptCount val="1"/>
                <c:pt idx="0">
                  <c:v>MdMYB124 OE #10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L$122:$M$122</c:f>
                <c:numCache>
                  <c:formatCode>General</c:formatCode>
                  <c:ptCount val="2"/>
                  <c:pt idx="0">
                    <c:v>339.17293998325</c:v>
                  </c:pt>
                  <c:pt idx="1">
                    <c:v>2228.66436607323</c:v>
                  </c:pt>
                </c:numCache>
              </c:numRef>
            </c:plus>
            <c:minus>
              <c:numRef>
                <c:f>'[MdMYB88124 根氧化物与叶代谢物 长期干旱.xlsx]Sheet3'!$L$122:$M$122</c:f>
                <c:numCache>
                  <c:formatCode>General</c:formatCode>
                  <c:ptCount val="2"/>
                  <c:pt idx="0">
                    <c:v>339.17293998325</c:v>
                  </c:pt>
                  <c:pt idx="1">
                    <c:v>2228.664366073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J$117:$K$117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J$122:$K$122</c:f>
              <c:numCache>
                <c:formatCode>General</c:formatCode>
                <c:ptCount val="2"/>
                <c:pt idx="0">
                  <c:v>17688.6278633333</c:v>
                </c:pt>
                <c:pt idx="1">
                  <c:v>12135.357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5328336"/>
        <c:axId val="1465328880"/>
      </c:barChart>
      <c:catAx>
        <c:axId val="146532833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28880"/>
        <c:crosses val="autoZero"/>
        <c:auto val="1"/>
        <c:lblAlgn val="ctr"/>
        <c:lblOffset val="100"/>
        <c:noMultiLvlLbl val="0"/>
      </c:catAx>
      <c:valAx>
        <c:axId val="14653288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28336"/>
        <c:crosses val="autoZero"/>
        <c:crossBetween val="between"/>
        <c:majorUnit val="2000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4863100252738"/>
          <c:y val="0.0932977913175933"/>
          <c:w val="0.478306655433867"/>
          <c:h val="0.384361359407596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63244029579343"/>
          <c:y val="0.0295116772823779"/>
          <c:w val="0.824111052698047"/>
          <c:h val="0.8826751592356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dMYB88124 根氧化物与叶代谢物 长期干旱.xlsx]Sheet3'!$B$146</c:f>
              <c:strCache>
                <c:ptCount val="1"/>
                <c:pt idx="0">
                  <c:v>GL-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46:$E$150</c:f>
                <c:numCache>
                  <c:formatCode>General</c:formatCode>
                  <c:ptCount val="5"/>
                  <c:pt idx="0">
                    <c:v>313.578366872207</c:v>
                  </c:pt>
                  <c:pt idx="1">
                    <c:v>112.177894146408</c:v>
                  </c:pt>
                  <c:pt idx="2">
                    <c:v>346.421326783842</c:v>
                  </c:pt>
                  <c:pt idx="3">
                    <c:v>129.895749701067</c:v>
                  </c:pt>
                  <c:pt idx="4">
                    <c:v>339.17293998325</c:v>
                  </c:pt>
                </c:numCache>
              </c:numRef>
            </c:plus>
            <c:minus>
              <c:numRef>
                <c:f>'[MdMYB88124 根氧化物与叶代谢物 长期干旱.xlsx]Sheet3'!$E$146:$E$150</c:f>
                <c:numCache>
                  <c:formatCode>General</c:formatCode>
                  <c:ptCount val="5"/>
                  <c:pt idx="0">
                    <c:v>313.578366872207</c:v>
                  </c:pt>
                  <c:pt idx="1">
                    <c:v>112.177894146408</c:v>
                  </c:pt>
                  <c:pt idx="2">
                    <c:v>346.421326783842</c:v>
                  </c:pt>
                  <c:pt idx="3">
                    <c:v>129.895749701067</c:v>
                  </c:pt>
                  <c:pt idx="4">
                    <c:v>339.172939983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45:$D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46:$D$146</c:f>
              <c:numCache>
                <c:formatCode>General</c:formatCode>
                <c:ptCount val="2"/>
                <c:pt idx="0">
                  <c:v>2221.78280333333</c:v>
                </c:pt>
                <c:pt idx="1">
                  <c:v>1756.73195333333</c:v>
                </c:pt>
              </c:numCache>
            </c:numRef>
          </c:val>
        </c:ser>
        <c:ser>
          <c:idx val="1"/>
          <c:order val="1"/>
          <c:tx>
            <c:strRef>
              <c:f>'[MdMYB88124 根氧化物与叶代谢物 长期干旱.xlsx]Sheet3'!$B$147</c:f>
              <c:strCache>
                <c:ptCount val="1"/>
                <c:pt idx="0">
                  <c:v>MdMYB88/124 RNAi #2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47:$F$147</c:f>
                <c:numCache>
                  <c:formatCode>General</c:formatCode>
                  <c:ptCount val="2"/>
                  <c:pt idx="0">
                    <c:v>112.177894146408</c:v>
                  </c:pt>
                  <c:pt idx="1">
                    <c:v>118.568912637824</c:v>
                  </c:pt>
                </c:numCache>
              </c:numRef>
            </c:plus>
            <c:minus>
              <c:numRef>
                <c:f>'[MdMYB88124 根氧化物与叶代谢物 长期干旱.xlsx]Sheet3'!$E$147:$F$147</c:f>
                <c:numCache>
                  <c:formatCode>General</c:formatCode>
                  <c:ptCount val="2"/>
                  <c:pt idx="0">
                    <c:v>112.177894146408</c:v>
                  </c:pt>
                  <c:pt idx="1">
                    <c:v>118.5689126378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45:$D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47:$D$147</c:f>
              <c:numCache>
                <c:formatCode>General</c:formatCode>
                <c:ptCount val="2"/>
                <c:pt idx="0">
                  <c:v>2388.37197</c:v>
                </c:pt>
                <c:pt idx="1">
                  <c:v>1717.91035666666</c:v>
                </c:pt>
              </c:numCache>
            </c:numRef>
          </c:val>
        </c:ser>
        <c:ser>
          <c:idx val="2"/>
          <c:order val="2"/>
          <c:tx>
            <c:strRef>
              <c:f>'[MdMYB88124 根氧化物与叶代谢物 长期干旱.xlsx]Sheet3'!$B$148</c:f>
              <c:strCache>
                <c:ptCount val="1"/>
                <c:pt idx="0">
                  <c:v>MdMYB88/124 RNAi #2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48:$F$148</c:f>
                <c:numCache>
                  <c:formatCode>General</c:formatCode>
                  <c:ptCount val="2"/>
                  <c:pt idx="0">
                    <c:v>346.421326783842</c:v>
                  </c:pt>
                  <c:pt idx="1">
                    <c:v>331.376251936383</c:v>
                  </c:pt>
                </c:numCache>
              </c:numRef>
            </c:plus>
            <c:minus>
              <c:numRef>
                <c:f>'[MdMYB88124 根氧化物与叶代谢物 长期干旱.xlsx]Sheet3'!$E$148:$F$148</c:f>
                <c:numCache>
                  <c:formatCode>General</c:formatCode>
                  <c:ptCount val="2"/>
                  <c:pt idx="0">
                    <c:v>346.421326783842</c:v>
                  </c:pt>
                  <c:pt idx="1">
                    <c:v>331.3762519363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45:$D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48:$D$148</c:f>
              <c:numCache>
                <c:formatCode>General</c:formatCode>
                <c:ptCount val="2"/>
                <c:pt idx="0">
                  <c:v>2890.52837333333</c:v>
                </c:pt>
                <c:pt idx="1">
                  <c:v>1340.87253333333</c:v>
                </c:pt>
              </c:numCache>
            </c:numRef>
          </c:val>
        </c:ser>
        <c:ser>
          <c:idx val="3"/>
          <c:order val="3"/>
          <c:tx>
            <c:strRef>
              <c:f>'[MdMYB88124 根氧化物与叶代谢物 长期干旱.xlsx]Sheet3'!$B$149</c:f>
              <c:strCache>
                <c:ptCount val="1"/>
                <c:pt idx="0">
                  <c:v>MdMYB88 OE #29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49:$F$149</c:f>
                <c:numCache>
                  <c:formatCode>General</c:formatCode>
                  <c:ptCount val="2"/>
                  <c:pt idx="0">
                    <c:v>129.895749701067</c:v>
                  </c:pt>
                  <c:pt idx="1">
                    <c:v>142.309726438309</c:v>
                  </c:pt>
                </c:numCache>
              </c:numRef>
            </c:plus>
            <c:minus>
              <c:numRef>
                <c:f>'[MdMYB88124 根氧化物与叶代谢物 长期干旱.xlsx]Sheet3'!$E$149:$F$149</c:f>
                <c:numCache>
                  <c:formatCode>General</c:formatCode>
                  <c:ptCount val="2"/>
                  <c:pt idx="0">
                    <c:v>129.895749701067</c:v>
                  </c:pt>
                  <c:pt idx="1">
                    <c:v>142.3097264383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45:$D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49:$D$149</c:f>
              <c:numCache>
                <c:formatCode>General</c:formatCode>
                <c:ptCount val="2"/>
                <c:pt idx="0">
                  <c:v>3000.82362</c:v>
                </c:pt>
                <c:pt idx="1">
                  <c:v>2317.0307</c:v>
                </c:pt>
              </c:numCache>
            </c:numRef>
          </c:val>
        </c:ser>
        <c:ser>
          <c:idx val="4"/>
          <c:order val="4"/>
          <c:tx>
            <c:strRef>
              <c:f>'[MdMYB88124 根氧化物与叶代谢物 长期干旱.xlsx]Sheet3'!$B$150</c:f>
              <c:strCache>
                <c:ptCount val="1"/>
                <c:pt idx="0">
                  <c:v>MdMYB124 OE #10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50:$F$150</c:f>
                <c:numCache>
                  <c:formatCode>General</c:formatCode>
                  <c:ptCount val="2"/>
                  <c:pt idx="0">
                    <c:v>339.17293998325</c:v>
                  </c:pt>
                  <c:pt idx="1">
                    <c:v>160.917531754555</c:v>
                  </c:pt>
                </c:numCache>
              </c:numRef>
            </c:plus>
            <c:minus>
              <c:numRef>
                <c:f>'[MdMYB88124 根氧化物与叶代谢物 长期干旱.xlsx]Sheet3'!$E$150:$F$150</c:f>
                <c:numCache>
                  <c:formatCode>General</c:formatCode>
                  <c:ptCount val="2"/>
                  <c:pt idx="0">
                    <c:v>339.17293998325</c:v>
                  </c:pt>
                  <c:pt idx="1">
                    <c:v>160.9175317545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C$145:$D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C$150:$D$150</c:f>
              <c:numCache>
                <c:formatCode>General</c:formatCode>
                <c:ptCount val="2"/>
                <c:pt idx="0">
                  <c:v>2570.04439333333</c:v>
                </c:pt>
                <c:pt idx="1">
                  <c:v>2011.033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5319632"/>
        <c:axId val="1465316912"/>
      </c:barChart>
      <c:catAx>
        <c:axId val="146531963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16912"/>
        <c:crosses val="autoZero"/>
        <c:auto val="1"/>
        <c:lblAlgn val="ctr"/>
        <c:lblOffset val="100"/>
        <c:noMultiLvlLbl val="0"/>
      </c:catAx>
      <c:valAx>
        <c:axId val="1465316912"/>
        <c:scaling>
          <c:orientation val="minMax"/>
          <c:max val="46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19632"/>
        <c:crosses val="autoZero"/>
        <c:crossBetween val="between"/>
        <c:majorUnit val="100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502316764953664"/>
          <c:y val="0.070854638422206"/>
          <c:w val="0.465880370682393"/>
          <c:h val="0.341855368882396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63244029579343"/>
          <c:y val="0.0296059637912673"/>
          <c:w val="0.839767075056829"/>
          <c:h val="0.8823003194888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dMYB88124 根氧化物与叶代谢物 长期干旱.xlsx]Sheet3'!$H$146</c:f>
              <c:strCache>
                <c:ptCount val="1"/>
                <c:pt idx="0">
                  <c:v>GL-3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K$146:$L$146</c:f>
                <c:numCache>
                  <c:formatCode>General</c:formatCode>
                  <c:ptCount val="2"/>
                  <c:pt idx="0">
                    <c:v>290.063842624913</c:v>
                  </c:pt>
                  <c:pt idx="1">
                    <c:v>177.186089229861</c:v>
                  </c:pt>
                </c:numCache>
              </c:numRef>
            </c:plus>
            <c:minus>
              <c:numRef>
                <c:f>'[MdMYB88124 根氧化物与叶代谢物 长期干旱.xlsx]Sheet3'!$K$146:$L$146</c:f>
                <c:numCache>
                  <c:formatCode>General</c:formatCode>
                  <c:ptCount val="2"/>
                  <c:pt idx="0">
                    <c:v>290.063842624913</c:v>
                  </c:pt>
                  <c:pt idx="1">
                    <c:v>177.1860892298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I$145:$J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I$146:$J$146</c:f>
              <c:numCache>
                <c:formatCode>General</c:formatCode>
                <c:ptCount val="2"/>
                <c:pt idx="0">
                  <c:v>1608.0607</c:v>
                </c:pt>
                <c:pt idx="1">
                  <c:v>1050.35293333333</c:v>
                </c:pt>
              </c:numCache>
            </c:numRef>
          </c:val>
        </c:ser>
        <c:ser>
          <c:idx val="1"/>
          <c:order val="1"/>
          <c:tx>
            <c:strRef>
              <c:f>'[MdMYB88124 根氧化物与叶代谢物 长期干旱.xlsx]Sheet3'!$H$147</c:f>
              <c:strCache>
                <c:ptCount val="1"/>
                <c:pt idx="0">
                  <c:v>MdMYB88/124 RNAi #2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E$147:$F$147</c:f>
                <c:numCache>
                  <c:formatCode>General</c:formatCode>
                  <c:ptCount val="2"/>
                  <c:pt idx="0">
                    <c:v>112.177894146408</c:v>
                  </c:pt>
                  <c:pt idx="1">
                    <c:v>118.568912637824</c:v>
                  </c:pt>
                </c:numCache>
              </c:numRef>
            </c:plus>
            <c:minus>
              <c:numRef>
                <c:f>'[MdMYB88124 根氧化物与叶代谢物 长期干旱.xlsx]Sheet3'!$E$147:$F$147</c:f>
                <c:numCache>
                  <c:formatCode>General</c:formatCode>
                  <c:ptCount val="2"/>
                  <c:pt idx="0">
                    <c:v>112.177894146408</c:v>
                  </c:pt>
                  <c:pt idx="1">
                    <c:v>118.5689126378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I$145:$J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I$147:$J$147</c:f>
              <c:numCache>
                <c:formatCode>General</c:formatCode>
                <c:ptCount val="2"/>
                <c:pt idx="0">
                  <c:v>1752.01031</c:v>
                </c:pt>
                <c:pt idx="1">
                  <c:v>976.46021</c:v>
                </c:pt>
              </c:numCache>
            </c:numRef>
          </c:val>
        </c:ser>
        <c:ser>
          <c:idx val="2"/>
          <c:order val="2"/>
          <c:tx>
            <c:strRef>
              <c:f>'[MdMYB88124 根氧化物与叶代谢物 长期干旱.xlsx]Sheet3'!$H$148</c:f>
              <c:strCache>
                <c:ptCount val="1"/>
                <c:pt idx="0">
                  <c:v>MdMYB88/124 RNAi #2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K$148:$L$148</c:f>
                <c:numCache>
                  <c:formatCode>General</c:formatCode>
                  <c:ptCount val="2"/>
                  <c:pt idx="0">
                    <c:v>84.01436425715</c:v>
                  </c:pt>
                  <c:pt idx="1">
                    <c:v>35.429482391521</c:v>
                  </c:pt>
                </c:numCache>
              </c:numRef>
            </c:plus>
            <c:minus>
              <c:numRef>
                <c:f>'[MdMYB88124 根氧化物与叶代谢物 长期干旱.xlsx]Sheet3'!$K$148:$L$148</c:f>
                <c:numCache>
                  <c:formatCode>General</c:formatCode>
                  <c:ptCount val="2"/>
                  <c:pt idx="0">
                    <c:v>84.01436425715</c:v>
                  </c:pt>
                  <c:pt idx="1">
                    <c:v>35.4294823915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I$145:$J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I$148:$J$148</c:f>
              <c:numCache>
                <c:formatCode>General</c:formatCode>
                <c:ptCount val="2"/>
                <c:pt idx="0">
                  <c:v>1491.60641</c:v>
                </c:pt>
                <c:pt idx="1">
                  <c:v>874.38853</c:v>
                </c:pt>
              </c:numCache>
            </c:numRef>
          </c:val>
        </c:ser>
        <c:ser>
          <c:idx val="3"/>
          <c:order val="3"/>
          <c:tx>
            <c:strRef>
              <c:f>'[MdMYB88124 根氧化物与叶代谢物 长期干旱.xlsx]Sheet3'!$H$149</c:f>
              <c:strCache>
                <c:ptCount val="1"/>
                <c:pt idx="0">
                  <c:v>MdMYB88 OE #29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K$149:$L$149</c:f>
                <c:numCache>
                  <c:formatCode>General</c:formatCode>
                  <c:ptCount val="2"/>
                  <c:pt idx="0">
                    <c:v>114.10612140785</c:v>
                  </c:pt>
                  <c:pt idx="1">
                    <c:v>118.990258921082</c:v>
                  </c:pt>
                </c:numCache>
              </c:numRef>
            </c:plus>
            <c:minus>
              <c:numRef>
                <c:f>'[MdMYB88124 根氧化物与叶代谢物 长期干旱.xlsx]Sheet3'!$K$149:$L$149</c:f>
                <c:numCache>
                  <c:formatCode>General</c:formatCode>
                  <c:ptCount val="2"/>
                  <c:pt idx="0">
                    <c:v>114.10612140785</c:v>
                  </c:pt>
                  <c:pt idx="1">
                    <c:v>118.9902589210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I$145:$J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I$149:$J$149</c:f>
              <c:numCache>
                <c:formatCode>General</c:formatCode>
                <c:ptCount val="2"/>
                <c:pt idx="0">
                  <c:v>1801.18464666667</c:v>
                </c:pt>
                <c:pt idx="1">
                  <c:v>1337.11352666667</c:v>
                </c:pt>
              </c:numCache>
            </c:numRef>
          </c:val>
        </c:ser>
        <c:ser>
          <c:idx val="4"/>
          <c:order val="4"/>
          <c:tx>
            <c:strRef>
              <c:f>'[MdMYB88124 根氧化物与叶代谢物 长期干旱.xlsx]Sheet3'!$H$150</c:f>
              <c:strCache>
                <c:ptCount val="1"/>
                <c:pt idx="0">
                  <c:v>MdMYB124 OE #10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MdMYB88124 根氧化物与叶代谢物 长期干旱.xlsx]Sheet3'!$K$150:$L$150</c:f>
                <c:numCache>
                  <c:formatCode>General</c:formatCode>
                  <c:ptCount val="2"/>
                  <c:pt idx="0">
                    <c:v>117.94006486763</c:v>
                  </c:pt>
                  <c:pt idx="1">
                    <c:v>32.2860538292145</c:v>
                  </c:pt>
                </c:numCache>
              </c:numRef>
            </c:plus>
            <c:minus>
              <c:numRef>
                <c:f>'[MdMYB88124 根氧化物与叶代谢物 长期干旱.xlsx]Sheet3'!$K$150:$L$150</c:f>
                <c:numCache>
                  <c:formatCode>General</c:formatCode>
                  <c:ptCount val="2"/>
                  <c:pt idx="0">
                    <c:v>117.94006486763</c:v>
                  </c:pt>
                  <c:pt idx="1">
                    <c:v>32.28605382921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dMYB88124 根氧化物与叶代谢物 长期干旱.xlsx]Sheet3'!$I$145:$J$145</c:f>
              <c:strCache>
                <c:ptCount val="2"/>
                <c:pt idx="0">
                  <c:v>Control</c:v>
                </c:pt>
                <c:pt idx="1">
                  <c:v>Drought</c:v>
                </c:pt>
              </c:strCache>
            </c:strRef>
          </c:cat>
          <c:val>
            <c:numRef>
              <c:f>'[MdMYB88124 根氧化物与叶代谢物 长期干旱.xlsx]Sheet3'!$I$150:$J$150</c:f>
              <c:numCache>
                <c:formatCode>General</c:formatCode>
                <c:ptCount val="2"/>
                <c:pt idx="0">
                  <c:v>1424.62413</c:v>
                </c:pt>
                <c:pt idx="1">
                  <c:v>1428.2915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5315824"/>
        <c:axId val="1465329968"/>
      </c:barChart>
      <c:catAx>
        <c:axId val="14653158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29968"/>
        <c:crosses val="autoZero"/>
        <c:auto val="1"/>
        <c:lblAlgn val="ctr"/>
        <c:lblOffset val="100"/>
        <c:noMultiLvlLbl val="0"/>
      </c:catAx>
      <c:valAx>
        <c:axId val="1465329968"/>
        <c:scaling>
          <c:orientation val="minMax"/>
          <c:max val="3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1465315824"/>
        <c:crosses val="autoZero"/>
        <c:crossBetween val="between"/>
        <c:majorUnit val="100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4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482548359966358"/>
          <c:y val="0.0612594113620808"/>
          <c:w val="0.447645079899075"/>
          <c:h val="0.370180288487449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>
          <a:solidFill>
            <a:schemeClr val="tx1"/>
          </a:solidFill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91F489-04D9-4213-83E5-1D8F78F28C1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DA67EB-B108-4DAE-B47D-17A3371D8F9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DA67EB-B108-4DAE-B47D-17A3371D8F9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92EB1-570B-4C80-8DE1-BF5CC55459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5AEF1-D32A-4C08-9B62-74DC80AD8847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5.png"/><Relationship Id="rId1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chart" Target="../charts/chart4.xml"/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412617" y="265794"/>
            <a:ext cx="3959401" cy="2505044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4740910" y="720090"/>
            <a:ext cx="409194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Quality control of metabolomics analysis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GL-3 and 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88/124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NAi lines under drought stress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PCA analysis. B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OPLS-DA analysis. </a:t>
            </a:r>
            <a:endParaRPr lang="en-US" altLang="zh-CN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89407" y="211986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89407" y="2963909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 descr="GL-3_Control_vs_MdMYB_Control_oplsd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4985" y="2771140"/>
            <a:ext cx="4011930" cy="4011930"/>
          </a:xfrm>
          <a:prstGeom prst="rect">
            <a:avLst/>
          </a:prstGeom>
        </p:spPr>
      </p:pic>
      <p:pic>
        <p:nvPicPr>
          <p:cNvPr id="18" name="图片 17" descr="GL-3_Drought_vs_MdMYB_Drought_oplsda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0910" y="2771140"/>
            <a:ext cx="4010400" cy="40104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5241925" y="537210"/>
            <a:ext cx="3380740" cy="355473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07085" y="786130"/>
            <a:ext cx="3896360" cy="330581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56945" y="4609465"/>
            <a:ext cx="723074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l Figure 1. Quality control of metabolomics analysis of GL-3 and 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88/124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NAi lines under drought stress. 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Clustered heat map . D. Pearson’s correlation analysis. </a:t>
            </a:r>
            <a:endParaRPr lang="zh-CN" altLang="en-US" sz="1200"/>
          </a:p>
        </p:txBody>
      </p:sp>
      <p:sp>
        <p:nvSpPr>
          <p:cNvPr id="7" name="文本框 6"/>
          <p:cNvSpPr txBox="1"/>
          <p:nvPr/>
        </p:nvSpPr>
        <p:spPr>
          <a:xfrm>
            <a:off x="248767" y="334374"/>
            <a:ext cx="4572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703292" y="334374"/>
            <a:ext cx="4572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86266" y="5250211"/>
            <a:ext cx="83701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Differential metabolites in phenylpropanoid biosynthesis pathwa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88/124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NAi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plants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der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-term drought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indicates that the metabolite content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MYB88/124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i lines is lower than GL-3. White indicates no difference in the content of metabolite, or undetected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 descr="https://www.genome.jp/tmp/mark_pathway156205693861421/map00940.png"/>
          <p:cNvPicPr>
            <a:picLocks noChangeAspect="1" noChangeArrowheads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0" t="426" b="4598"/>
          <a:stretch>
            <a:fillRect/>
          </a:stretch>
        </p:blipFill>
        <p:spPr bwMode="auto">
          <a:xfrm>
            <a:off x="103231" y="464820"/>
            <a:ext cx="9040769" cy="4564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J:\原桌面内容\MWXS-18-132_西北农林科技大学12个苹果广泛靶向代谢组检测技术开发结题报告_2018-09-03\ko00941-RNA.pngko00941-RNA"/>
          <p:cNvPicPr/>
          <p:nvPr/>
        </p:nvPicPr>
        <p:blipFill rotWithShape="1">
          <a:blip r:embed="rId1" cstate="print"/>
          <a:srcRect l="1542" t="3408" r="1851" b="3514"/>
          <a:stretch>
            <a:fillRect/>
          </a:stretch>
        </p:blipFill>
        <p:spPr>
          <a:xfrm>
            <a:off x="83821" y="495301"/>
            <a:ext cx="9006840" cy="4811212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34523" y="5306513"/>
            <a:ext cx="83701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Differential metabolites in flavonoid biosynthesis pathwa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88/124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NAi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lants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long-term drought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indicates that the metabolite content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MYB88/1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RNAi lines is lower than GL-3. White indicates no difference in the content of metabolite, or undetected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J:\原桌面内容\MWXS-18-132_西北农林科技大学12个苹果广泛靶向代谢组检测技术开发结题报告_2018-09-03\ko00944-RNA.pngko00944-RNA"/>
          <p:cNvPicPr/>
          <p:nvPr/>
        </p:nvPicPr>
        <p:blipFill rotWithShape="1">
          <a:blip r:embed="rId1" cstate="print"/>
          <a:srcRect l="2563" t="4155" r="1583" b="3739"/>
          <a:stretch>
            <a:fillRect/>
          </a:stretch>
        </p:blipFill>
        <p:spPr>
          <a:xfrm>
            <a:off x="234396" y="647700"/>
            <a:ext cx="8764824" cy="413004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41815" y="3807495"/>
            <a:ext cx="7209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dirty="0"/>
          </a:p>
          <a:p>
            <a:endParaRPr lang="en-US" altLang="zh-CN" dirty="0"/>
          </a:p>
        </p:txBody>
      </p:sp>
      <p:sp>
        <p:nvSpPr>
          <p:cNvPr id="2" name="文本框 1"/>
          <p:cNvSpPr txBox="1"/>
          <p:nvPr/>
        </p:nvSpPr>
        <p:spPr>
          <a:xfrm>
            <a:off x="234396" y="4835234"/>
            <a:ext cx="837015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Differential metabolites in flavone and flavonol biosynthesis pathway in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88/124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NAi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plant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long-term drought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indicates that the metabolite content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MYB88/124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i lines is lower than GL-3. White indicates no difference in the content of metabolite, or undetected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1"/>
          <p:cNvPicPr>
            <a:picLocks noGrp="1" noChangeAspect="1"/>
          </p:cNvPicPr>
          <p:nvPr>
            <p:ph idx="1"/>
          </p:nvPr>
        </p:nvPicPr>
        <p:blipFill>
          <a:blip r:embed="rId1"/>
          <a:srcRect l="908" r="18783"/>
          <a:stretch>
            <a:fillRect/>
          </a:stretch>
        </p:blipFill>
        <p:spPr>
          <a:xfrm>
            <a:off x="1458807" y="587012"/>
            <a:ext cx="5553287" cy="539877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1185334" y="6074364"/>
            <a:ext cx="6773333" cy="2755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/>
            <a:r>
              <a:rPr lang="en-US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5. Amino acid sequence alignment of </a:t>
            </a:r>
            <a:r>
              <a:rPr lang="en-US" sz="1200" b="1" dirty="0" err="1" smtClean="0">
                <a:latin typeface="Times New Roman" panose="02020603050405020304" pitchFamily="18" charset="0"/>
                <a:ea typeface="宋体" panose="02010600030101010101" pitchFamily="2" charset="-122"/>
              </a:rPr>
              <a:t>MdCMs</a:t>
            </a:r>
            <a:r>
              <a:rPr lang="en-US" sz="1200" b="1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en-US" altLang="en-US" sz="1200" b="1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48" descr="5AMSO_89XFK2WNE6J`R4~O0"/>
          <p:cNvPicPr>
            <a:picLocks noGrp="1" noChangeAspect="1"/>
          </p:cNvPicPr>
          <p:nvPr>
            <p:ph idx="1"/>
          </p:nvPr>
        </p:nvPicPr>
        <p:blipFill>
          <a:blip r:embed="rId1"/>
          <a:stretch>
            <a:fillRect/>
          </a:stretch>
        </p:blipFill>
        <p:spPr>
          <a:xfrm>
            <a:off x="977900" y="932022"/>
            <a:ext cx="6474460" cy="2407444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977901" y="3451860"/>
            <a:ext cx="6489700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6. Analysis of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MdCM2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promoter sequence.</a:t>
            </a:r>
            <a:r>
              <a:rPr lang="en-US" sz="1200" b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Binding site of MdMYB88 and MdMYB124 was shown with red color. </a:t>
            </a:r>
            <a:r>
              <a:rPr lang="en-US" sz="1200" b="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DNA</a:t>
            </a:r>
            <a:r>
              <a:rPr lang="en-US" sz="1200" b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sequences of </a:t>
            </a:r>
            <a:r>
              <a:rPr lang="en-US" sz="1200" b="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MdCM2</a:t>
            </a:r>
            <a:r>
              <a:rPr lang="en-US" sz="1200" b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was marked with yello</a:t>
            </a:r>
            <a:r>
              <a:rPr lang="en-US" sz="1200" b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US" sz="1200" b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color. Sequences underlined indicate PCR products of two fragments.</a:t>
            </a:r>
            <a:endParaRPr lang="en-US" altLang="en-US" sz="1200" b="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内容占位符 5"/>
          <p:cNvGraphicFramePr>
            <a:graphicFrameLocks noGrp="1"/>
          </p:cNvGraphicFramePr>
          <p:nvPr>
            <p:ph idx="1"/>
          </p:nvPr>
        </p:nvGraphicFramePr>
        <p:xfrm>
          <a:off x="2651786" y="337397"/>
          <a:ext cx="4128459" cy="1414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8" name="文本框 7"/>
          <p:cNvSpPr txBox="1"/>
          <p:nvPr/>
        </p:nvSpPr>
        <p:spPr>
          <a:xfrm rot="16200000">
            <a:off x="1745663" y="648791"/>
            <a:ext cx="112918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ve Content of  </a:t>
            </a:r>
            <a:r>
              <a:rPr lang="en-US" altLang="zh-CN" sz="9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llic</a:t>
            </a:r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cid (peak area</a:t>
            </a:r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/g FW</a:t>
            </a:r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图表 9"/>
          <p:cNvGraphicFramePr/>
          <p:nvPr/>
        </p:nvGraphicFramePr>
        <p:xfrm>
          <a:off x="2528357" y="1664313"/>
          <a:ext cx="4299512" cy="12506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3"/>
          <p:cNvSpPr txBox="1"/>
          <p:nvPr/>
        </p:nvSpPr>
        <p:spPr>
          <a:xfrm rot="16200000">
            <a:off x="1745663" y="2079109"/>
            <a:ext cx="112918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ve Content of  </a:t>
            </a:r>
            <a:r>
              <a:rPr lang="en-US" altLang="zh-CN" sz="9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lorizin</a:t>
            </a:r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peak area/g FW)</a:t>
            </a:r>
            <a:endParaRPr lang="en-US" altLang="zh-CN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图表 8"/>
          <p:cNvGraphicFramePr/>
          <p:nvPr/>
        </p:nvGraphicFramePr>
        <p:xfrm>
          <a:off x="2664636" y="2948815"/>
          <a:ext cx="4403824" cy="1303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文本框 4"/>
          <p:cNvSpPr txBox="1"/>
          <p:nvPr/>
        </p:nvSpPr>
        <p:spPr>
          <a:xfrm rot="16200000">
            <a:off x="1730899" y="3336125"/>
            <a:ext cx="1158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ve Content of  </a:t>
            </a:r>
            <a:r>
              <a:rPr lang="en-US" altLang="zh-CN" sz="9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utin</a:t>
            </a:r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peak area)</a:t>
            </a:r>
            <a:endParaRPr lang="en-US" altLang="zh-CN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图表 10"/>
          <p:cNvGraphicFramePr/>
          <p:nvPr/>
        </p:nvGraphicFramePr>
        <p:xfrm>
          <a:off x="2668333" y="4252788"/>
          <a:ext cx="4349327" cy="13916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文本框 6"/>
          <p:cNvSpPr txBox="1"/>
          <p:nvPr/>
        </p:nvSpPr>
        <p:spPr>
          <a:xfrm rot="16200000">
            <a:off x="1730899" y="4693721"/>
            <a:ext cx="115871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ve Content of  </a:t>
            </a:r>
            <a:r>
              <a:rPr lang="en-US" altLang="zh-CN" sz="9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ffeic</a:t>
            </a:r>
            <a:r>
              <a:rPr lang="en-US" altLang="zh-CN" sz="9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cid (peak area)</a:t>
            </a:r>
            <a:endParaRPr lang="en-US" altLang="zh-CN" sz="9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976086" y="5770244"/>
            <a:ext cx="75564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. 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ontent of gallic acid (A), phlorizin (B), rutin (C) and caffeic acid (D) in leaves of GL-3, 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88,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nd </a:t>
            </a:r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dMYB12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4 transgenic plants under drought stess.</a:t>
            </a:r>
            <a:endParaRPr lang="en-US" altLang="zh-CN" sz="1200" b="1" dirty="0" smtClean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607947" y="338350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607947" y="1598171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607947" y="2948816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607947" y="4100388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altLang="zh-CN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16</Words>
  <Application>WPS 演示</Application>
  <PresentationFormat>信纸(8.5x11 英寸)</PresentationFormat>
  <Paragraphs>42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8" baseType="lpstr">
      <vt:lpstr>Arial</vt:lpstr>
      <vt:lpstr>宋体</vt:lpstr>
      <vt:lpstr>Wingdings</vt:lpstr>
      <vt:lpstr>Times New Roman</vt:lpstr>
      <vt:lpstr>微软雅黑</vt:lpstr>
      <vt:lpstr>Arial Unicode MS</vt:lpstr>
      <vt:lpstr>Calibri Light</vt:lpstr>
      <vt:lpstr>Calibri</vt:lpstr>
      <vt:lpstr>等线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chi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太史令</cp:lastModifiedBy>
  <cp:revision>90</cp:revision>
  <dcterms:created xsi:type="dcterms:W3CDTF">2019-01-18T01:28:00Z</dcterms:created>
  <dcterms:modified xsi:type="dcterms:W3CDTF">2020-04-15T02:44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584</vt:lpwstr>
  </property>
</Properties>
</file>